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61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60" d="100"/>
          <a:sy n="60" d="100"/>
        </p:scale>
        <p:origin x="72" y="21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B0B4453-1717-418A-92CE-261F42F734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4E0F0035-0E90-483E-B7C5-7D2EFC8717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C9CE751-02EC-4448-9952-E8F64B48D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AF2E096-9593-4250-B980-089F85C2A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EB366C4-1644-4B51-9AAC-5A9798690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8281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4F4570D-2E6D-4017-BE80-F02D9BF497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FEA720D-F3D1-4881-85C5-5BE335C69A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6F02EA9-0BB9-4BFC-B483-FB5F17956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2DAF1CAC-ED00-4322-A8F9-7786AE127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9788167-DC31-4537-B382-770C091EA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6695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70980CA3-85E3-469E-A3DA-18870C82802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FC39A9F-98B5-4195-8176-3270A67B50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D1D84E2-4CE2-4E94-8B57-CEE901974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FCAB026-3EC6-45AE-9C6B-9AA309B71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B0384CF-7628-495A-8EF5-7647507325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55044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3FB3E44-3508-4FDB-8CB2-1238282608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4EAC310-D2E0-4152-A28A-1346E0DA95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5B50D9C-D503-4E60-9ACD-133737102A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94C590A-E53D-40AD-9D6C-23995C88B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E45015E-3D39-40AB-A40A-5185DB365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229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1F41028-C2ED-44B2-BBE6-075A09FFF3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E83D148-31AB-4C3B-B0A7-62C7ACB4A4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98896A2-0CA7-497F-9118-6C32DF823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F9EB013-B62B-4E54-BAD7-4A1C9AD7D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C2DA7B-BAEA-4A7F-AECE-6E06BC326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77419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22BE459-4F1E-41FB-B1CE-D6F3A75418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920D8A9-81A4-4DDB-890E-996BF1717E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FA5AE88C-BFBC-4B53-B9CF-F3C5238A6F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DD923A87-45C6-4B18-8D4D-06B4DC731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C4222F1-FBE6-48CD-8038-86734DD7B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AEEA4D4-EAA6-4F4E-914A-98BE93921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3544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13D25DB-2F8A-4082-8D87-DDBF1128D7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2D9B8A0-E0D9-471F-A0B5-03BC6DBB49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159A365-249A-409F-8C3E-8C86728982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E8581C8E-CD0B-4C6D-B4E0-4C3CD533F8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CB190A68-7786-4B03-A362-8978FFAD38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F8098010-3791-4701-B6AD-ABB0F50BCE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6EA6A3E-8BFC-413F-BF36-4D6B1039B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15E616D6-D444-492E-A3CC-EBA1E785F3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0546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62C31A2-4712-4368-9ED0-1F23E33F4E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9785D2A2-F185-4A17-936D-03533B80B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F634D530-9AD2-42CD-95A0-BCBE8F825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52E9FDE-FF4F-4053-9000-A918D3BBF9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711612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2FFD092F-DB88-48B2-A8FA-FC4767C463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E0111C3F-169C-485C-A867-7BD5F4D3A1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D1CB56A1-AA5C-46B9-A020-64FDE6C6B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5129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ADD0C9F-60BB-4588-B40C-FE407A9566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0B61CEC-72DD-4789-A8D5-E249595369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23C59FDA-2D71-446F-93DD-A888899AFC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95731D3-A0BA-4327-94F6-7DD256491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768EDB6-E37E-4744-B3EB-DB58AA5A7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520AC49-A0C2-4A48-8FD7-33589B94A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7263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94EA75B-FBDA-4A17-BAA0-133101095C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D44E255D-E826-413B-A49D-F7AAD49326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1990CFF-EE06-4047-9119-2517698491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E974E87-8A6A-4619-9C54-103E8DD15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4280655-FE40-44F0-A2A2-3DAE200ED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4E7FC0C-E477-42C4-A836-97A5E4793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8217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F6F83522-C07C-479B-8F7F-AFFDDB76CD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7EB35F8-3704-450B-AD76-312EC4FC43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D89FE2D-BB8F-4A8A-97F3-25B1F58FFC8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575B1A-E045-489C-BE74-30A892C95DD0}" type="datetimeFigureOut">
              <a:rPr lang="fr-FR" smtClean="0"/>
              <a:t>05/11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7F48958-1647-43C4-87E7-7FD7C08CF2F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0A2452A-3CEF-479C-97D0-07EB6CD345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EA7969-3A58-4305-960A-93E8F6068DB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4110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>
            <a:extLst>
              <a:ext uri="{FF2B5EF4-FFF2-40B4-BE49-F238E27FC236}">
                <a16:creationId xmlns:a16="http://schemas.microsoft.com/office/drawing/2014/main" id="{22D318E2-4830-4941-AFCB-63FD324FAF64}"/>
              </a:ext>
            </a:extLst>
          </p:cNvPr>
          <p:cNvGrpSpPr/>
          <p:nvPr/>
        </p:nvGrpSpPr>
        <p:grpSpPr>
          <a:xfrm>
            <a:off x="207579" y="247680"/>
            <a:ext cx="11751968" cy="6037150"/>
            <a:chOff x="102479" y="247680"/>
            <a:chExt cx="11751968" cy="6037150"/>
          </a:xfrm>
        </p:grpSpPr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CA026455-A9BB-42DE-AD65-8D304DD61675}"/>
                </a:ext>
              </a:extLst>
            </p:cNvPr>
            <p:cNvSpPr txBox="1"/>
            <p:nvPr/>
          </p:nvSpPr>
          <p:spPr>
            <a:xfrm>
              <a:off x="303658" y="247680"/>
              <a:ext cx="201237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Un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endParaRPr lang="fr-FR" sz="1400" b="1" dirty="0"/>
            </a:p>
          </p:txBody>
        </p:sp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3E095E98-FB10-4632-ABAC-8D5D7E24BB14}"/>
                </a:ext>
              </a:extLst>
            </p:cNvPr>
            <p:cNvSpPr txBox="1"/>
            <p:nvPr/>
          </p:nvSpPr>
          <p:spPr>
            <a:xfrm>
              <a:off x="9360944" y="2672719"/>
              <a:ext cx="190862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labeled</a:t>
              </a:r>
              <a:r>
                <a:rPr lang="fr-FR" sz="1200" dirty="0"/>
                <a:t> </a:t>
              </a:r>
              <a:r>
                <a:rPr lang="fr-FR" sz="1200" dirty="0" err="1"/>
                <a:t>monoctyes</a:t>
              </a:r>
              <a:r>
                <a:rPr lang="fr-FR" sz="1200" dirty="0"/>
                <a:t>-macrophages</a:t>
              </a:r>
            </a:p>
          </p:txBody>
        </p:sp>
        <p:sp>
          <p:nvSpPr>
            <p:cNvPr id="24" name="ZoneTexte 23">
              <a:extLst>
                <a:ext uri="{FF2B5EF4-FFF2-40B4-BE49-F238E27FC236}">
                  <a16:creationId xmlns:a16="http://schemas.microsoft.com/office/drawing/2014/main" id="{98F442FB-E16F-48C2-8300-436C8FCB20B1}"/>
                </a:ext>
              </a:extLst>
            </p:cNvPr>
            <p:cNvSpPr txBox="1"/>
            <p:nvPr/>
          </p:nvSpPr>
          <p:spPr>
            <a:xfrm>
              <a:off x="247018" y="2405978"/>
              <a:ext cx="20123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</a:t>
              </a:r>
              <a:r>
                <a:rPr lang="fr-FR" sz="1400" b="1" dirty="0" err="1"/>
                <a:t>wild</a:t>
              </a:r>
              <a:r>
                <a:rPr lang="fr-FR" sz="1400" b="1" dirty="0"/>
                <a:t>-type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26" name="ZoneTexte 25">
              <a:extLst>
                <a:ext uri="{FF2B5EF4-FFF2-40B4-BE49-F238E27FC236}">
                  <a16:creationId xmlns:a16="http://schemas.microsoft.com/office/drawing/2014/main" id="{B679AC25-A109-4D68-AE69-D05E667E6BF3}"/>
                </a:ext>
              </a:extLst>
            </p:cNvPr>
            <p:cNvSpPr txBox="1"/>
            <p:nvPr/>
          </p:nvSpPr>
          <p:spPr>
            <a:xfrm>
              <a:off x="9370951" y="379778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01D3C4F2-309A-4C18-BF71-65F2682EA3EF}"/>
                </a:ext>
              </a:extLst>
            </p:cNvPr>
            <p:cNvSpPr txBox="1"/>
            <p:nvPr/>
          </p:nvSpPr>
          <p:spPr>
            <a:xfrm>
              <a:off x="102479" y="4452022"/>
              <a:ext cx="25378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err="1"/>
                <a:t>Infected</a:t>
              </a:r>
              <a:r>
                <a:rPr lang="fr-FR" sz="1400" b="1" dirty="0"/>
                <a:t> </a:t>
              </a:r>
              <a:r>
                <a:rPr lang="fr-FR" sz="1400" b="1" dirty="0" err="1"/>
                <a:t>chicks</a:t>
              </a:r>
              <a:r>
                <a:rPr lang="fr-FR" sz="1400" b="1" dirty="0"/>
                <a:t> by the 3</a:t>
              </a:r>
              <a:r>
                <a:rPr lang="el-GR" sz="1400" b="1" dirty="0"/>
                <a:t>Δ</a:t>
              </a:r>
              <a:r>
                <a:rPr lang="fr-FR" sz="1400" b="1" dirty="0"/>
                <a:t> </a:t>
              </a:r>
              <a:r>
                <a:rPr lang="fr-FR" sz="1400" b="1" dirty="0" err="1"/>
                <a:t>strain</a:t>
              </a:r>
              <a:endParaRPr lang="fr-FR" sz="1400" b="1" dirty="0"/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86EFF6E0-B7BE-46C0-9302-C50A21ADD3AF}"/>
                </a:ext>
              </a:extLst>
            </p:cNvPr>
            <p:cNvSpPr txBox="1"/>
            <p:nvPr/>
          </p:nvSpPr>
          <p:spPr>
            <a:xfrm>
              <a:off x="9370951" y="5994575"/>
              <a:ext cx="248349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Infected</a:t>
              </a:r>
              <a:r>
                <a:rPr lang="fr-FR" sz="1200" dirty="0"/>
                <a:t> </a:t>
              </a:r>
              <a:r>
                <a:rPr lang="fr-FR" sz="1200" dirty="0" err="1"/>
                <a:t>unlabeled</a:t>
              </a:r>
              <a:r>
                <a:rPr lang="fr-FR" sz="1200" dirty="0"/>
                <a:t>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9238B342-6126-4A1A-9010-75B7981EF156}"/>
                </a:ext>
              </a:extLst>
            </p:cNvPr>
            <p:cNvSpPr txBox="1"/>
            <p:nvPr/>
          </p:nvSpPr>
          <p:spPr>
            <a:xfrm>
              <a:off x="1289017" y="877775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3" name="ZoneTexte 32">
              <a:extLst>
                <a:ext uri="{FF2B5EF4-FFF2-40B4-BE49-F238E27FC236}">
                  <a16:creationId xmlns:a16="http://schemas.microsoft.com/office/drawing/2014/main" id="{97A99491-2D1B-497C-82EA-96D163338B05}"/>
                </a:ext>
              </a:extLst>
            </p:cNvPr>
            <p:cNvSpPr txBox="1"/>
            <p:nvPr/>
          </p:nvSpPr>
          <p:spPr>
            <a:xfrm>
              <a:off x="1309845" y="3054398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4" name="ZoneTexte 33">
              <a:extLst>
                <a:ext uri="{FF2B5EF4-FFF2-40B4-BE49-F238E27FC236}">
                  <a16:creationId xmlns:a16="http://schemas.microsoft.com/office/drawing/2014/main" id="{BFA6729E-1564-4DE0-8970-E67A88961C76}"/>
                </a:ext>
              </a:extLst>
            </p:cNvPr>
            <p:cNvSpPr txBox="1"/>
            <p:nvPr/>
          </p:nvSpPr>
          <p:spPr>
            <a:xfrm>
              <a:off x="1253206" y="5301844"/>
              <a:ext cx="11647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Isotype control</a:t>
              </a:r>
            </a:p>
          </p:txBody>
        </p:sp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BD24A082-87FB-40AB-9AEA-F3A7CE6818C7}"/>
                </a:ext>
              </a:extLst>
            </p:cNvPr>
            <p:cNvSpPr txBox="1"/>
            <p:nvPr/>
          </p:nvSpPr>
          <p:spPr>
            <a:xfrm>
              <a:off x="5851089" y="481540"/>
              <a:ext cx="15135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Labeled</a:t>
              </a:r>
              <a:r>
                <a:rPr lang="fr-FR" sz="1200" dirty="0"/>
                <a:t> monocytes-macrophages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4A201F4E-6FCB-43A9-AE3F-8A1950B5E89A}"/>
                </a:ext>
              </a:extLst>
            </p:cNvPr>
            <p:cNvSpPr txBox="1"/>
            <p:nvPr/>
          </p:nvSpPr>
          <p:spPr>
            <a:xfrm>
              <a:off x="5948814" y="6007831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0320534D-BA65-4729-A678-FC6B0FF2FCF9}"/>
                </a:ext>
              </a:extLst>
            </p:cNvPr>
            <p:cNvSpPr txBox="1"/>
            <p:nvPr/>
          </p:nvSpPr>
          <p:spPr>
            <a:xfrm>
              <a:off x="5955455" y="3822197"/>
              <a:ext cx="13180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err="1"/>
                <a:t>Unlabeled</a:t>
              </a:r>
              <a:r>
                <a:rPr lang="fr-FR" sz="1200" dirty="0"/>
                <a:t>  </a:t>
              </a:r>
              <a:r>
                <a:rPr lang="fr-FR" sz="1200" dirty="0" err="1"/>
                <a:t>cells</a:t>
              </a:r>
              <a:endParaRPr lang="fr-FR" sz="1200" dirty="0"/>
            </a:p>
          </p:txBody>
        </p:sp>
      </p:grpSp>
      <p:sp>
        <p:nvSpPr>
          <p:cNvPr id="41" name="ZoneTexte 40">
            <a:extLst>
              <a:ext uri="{FF2B5EF4-FFF2-40B4-BE49-F238E27FC236}">
                <a16:creationId xmlns:a16="http://schemas.microsoft.com/office/drawing/2014/main" id="{767BB29B-24FB-4CE7-8123-E1A816F4AC24}"/>
              </a:ext>
            </a:extLst>
          </p:cNvPr>
          <p:cNvSpPr txBox="1"/>
          <p:nvPr/>
        </p:nvSpPr>
        <p:spPr>
          <a:xfrm>
            <a:off x="10163712" y="287161"/>
            <a:ext cx="1619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S1 </a:t>
            </a:r>
            <a:r>
              <a:rPr lang="fr-FR" b="1" dirty="0" err="1"/>
              <a:t>Fig</a:t>
            </a:r>
            <a:endParaRPr lang="fr-FR" b="1" dirty="0"/>
          </a:p>
        </p:txBody>
      </p:sp>
      <p:pic>
        <p:nvPicPr>
          <p:cNvPr id="29" name="Picture 13" descr="C:\Users\trs-confocal\AppData\Local\Temp\tmp08989282277824255468.png">
            <a:extLst>
              <a:ext uri="{FF2B5EF4-FFF2-40B4-BE49-F238E27FC236}">
                <a16:creationId xmlns:a16="http://schemas.microsoft.com/office/drawing/2014/main" id="{C4D6178C-68DB-4477-B62F-39E2F7B6887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8899" y="287161"/>
            <a:ext cx="1954334" cy="20463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16" descr="C:\Users\trs-confocal\AppData\Local\Temp\tmp07387667260820552359.png">
            <a:extLst>
              <a:ext uri="{FF2B5EF4-FFF2-40B4-BE49-F238E27FC236}">
                <a16:creationId xmlns:a16="http://schemas.microsoft.com/office/drawing/2014/main" id="{E7F9C807-6F61-4B0B-BAEA-7C5D9B7DD1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80017" y="2570202"/>
            <a:ext cx="1933283" cy="19759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8" name="Groupe 37">
            <a:extLst>
              <a:ext uri="{FF2B5EF4-FFF2-40B4-BE49-F238E27FC236}">
                <a16:creationId xmlns:a16="http://schemas.microsoft.com/office/drawing/2014/main" id="{9B600464-FF12-4E3F-96F7-C736FB29740C}"/>
              </a:ext>
            </a:extLst>
          </p:cNvPr>
          <p:cNvGrpSpPr/>
          <p:nvPr/>
        </p:nvGrpSpPr>
        <p:grpSpPr>
          <a:xfrm>
            <a:off x="2878898" y="4696718"/>
            <a:ext cx="1954333" cy="2046386"/>
            <a:chOff x="1363620" y="2547326"/>
            <a:chExt cx="1832621" cy="1889786"/>
          </a:xfrm>
        </p:grpSpPr>
        <p:grpSp>
          <p:nvGrpSpPr>
            <p:cNvPr id="39" name="Groupe 38">
              <a:extLst>
                <a:ext uri="{FF2B5EF4-FFF2-40B4-BE49-F238E27FC236}">
                  <a16:creationId xmlns:a16="http://schemas.microsoft.com/office/drawing/2014/main" id="{2CDCF5A7-836B-4EEF-9ACC-B9A41BE15EA0}"/>
                </a:ext>
              </a:extLst>
            </p:cNvPr>
            <p:cNvGrpSpPr/>
            <p:nvPr/>
          </p:nvGrpSpPr>
          <p:grpSpPr>
            <a:xfrm>
              <a:off x="1363620" y="2547326"/>
              <a:ext cx="1832621" cy="1889786"/>
              <a:chOff x="1363620" y="2547326"/>
              <a:chExt cx="1832621" cy="1889786"/>
            </a:xfrm>
          </p:grpSpPr>
          <p:grpSp>
            <p:nvGrpSpPr>
              <p:cNvPr id="46" name="Groupe 45">
                <a:extLst>
                  <a:ext uri="{FF2B5EF4-FFF2-40B4-BE49-F238E27FC236}">
                    <a16:creationId xmlns:a16="http://schemas.microsoft.com/office/drawing/2014/main" id="{868719AB-48CC-4E6B-91F2-6481E7A55F98}"/>
                  </a:ext>
                </a:extLst>
              </p:cNvPr>
              <p:cNvGrpSpPr/>
              <p:nvPr/>
            </p:nvGrpSpPr>
            <p:grpSpPr>
              <a:xfrm>
                <a:off x="1363620" y="2547326"/>
                <a:ext cx="1832621" cy="1889786"/>
                <a:chOff x="1658133" y="2492896"/>
                <a:chExt cx="1674490" cy="1753361"/>
              </a:xfrm>
            </p:grpSpPr>
            <p:grpSp>
              <p:nvGrpSpPr>
                <p:cNvPr id="54" name="Groupe 53">
                  <a:extLst>
                    <a:ext uri="{FF2B5EF4-FFF2-40B4-BE49-F238E27FC236}">
                      <a16:creationId xmlns:a16="http://schemas.microsoft.com/office/drawing/2014/main" id="{07623DA4-193E-4C06-ADF3-08AFD14FF77A}"/>
                    </a:ext>
                  </a:extLst>
                </p:cNvPr>
                <p:cNvGrpSpPr/>
                <p:nvPr/>
              </p:nvGrpSpPr>
              <p:grpSpPr>
                <a:xfrm>
                  <a:off x="1658133" y="2492896"/>
                  <a:ext cx="1674490" cy="1753361"/>
                  <a:chOff x="1658133" y="2492896"/>
                  <a:chExt cx="1674490" cy="1753361"/>
                </a:xfrm>
              </p:grpSpPr>
              <p:pic>
                <p:nvPicPr>
                  <p:cNvPr id="56" name="Picture 16" descr="C:\Users\trs-confocal\AppData\Local\Temp\tmp07387667260820552359.png">
                    <a:extLst>
                      <a:ext uri="{FF2B5EF4-FFF2-40B4-BE49-F238E27FC236}">
                        <a16:creationId xmlns:a16="http://schemas.microsoft.com/office/drawing/2014/main" id="{F83B1604-2670-4F30-8D94-6758AB64F601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658133" y="2492896"/>
                    <a:ext cx="1674490" cy="1753361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57" name="ZoneTexte 56">
                    <a:extLst>
                      <a:ext uri="{FF2B5EF4-FFF2-40B4-BE49-F238E27FC236}">
                        <a16:creationId xmlns:a16="http://schemas.microsoft.com/office/drawing/2014/main" id="{C0E12F2D-AD7D-4515-9E38-A1769DDC5A78}"/>
                      </a:ext>
                    </a:extLst>
                  </p:cNvPr>
                  <p:cNvSpPr txBox="1"/>
                  <p:nvPr/>
                </p:nvSpPr>
                <p:spPr>
                  <a:xfrm>
                    <a:off x="2482852" y="3687320"/>
                    <a:ext cx="648988" cy="25502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endParaRPr lang="fr-FR" dirty="0"/>
                  </a:p>
                </p:txBody>
              </p:sp>
            </p:grpSp>
            <p:pic>
              <p:nvPicPr>
                <p:cNvPr id="55" name="Picture 18">
                  <a:extLst>
                    <a:ext uri="{FF2B5EF4-FFF2-40B4-BE49-F238E27FC236}">
                      <a16:creationId xmlns:a16="http://schemas.microsoft.com/office/drawing/2014/main" id="{3FCC2DC0-A216-45C7-B5FC-0664CA14215C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781" t="30971"/>
                <a:stretch/>
              </p:blipFill>
              <p:spPr bwMode="auto">
                <a:xfrm>
                  <a:off x="2577439" y="3031272"/>
                  <a:ext cx="755184" cy="1211994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113C8213-6FD8-4512-809A-CA1035BC2CC2}"/>
                  </a:ext>
                </a:extLst>
              </p:cNvPr>
              <p:cNvSpPr/>
              <p:nvPr/>
            </p:nvSpPr>
            <p:spPr>
              <a:xfrm>
                <a:off x="1619672" y="2559852"/>
                <a:ext cx="1224136" cy="16159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40" name="Picture 17">
              <a:extLst>
                <a:ext uri="{FF2B5EF4-FFF2-40B4-BE49-F238E27FC236}">
                  <a16:creationId xmlns:a16="http://schemas.microsoft.com/office/drawing/2014/main" id="{323EFABB-F5DB-40F5-B8E1-4F5A374CACDA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88682"/>
            <a:stretch/>
          </p:blipFill>
          <p:spPr bwMode="auto">
            <a:xfrm>
              <a:off x="1376146" y="2547326"/>
              <a:ext cx="1810745" cy="21723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58" name="Picture 4" descr="C:\Users\trs-confocal\AppData\Local\Temp\tmp03934104162084913275.png">
            <a:extLst>
              <a:ext uri="{FF2B5EF4-FFF2-40B4-BE49-F238E27FC236}">
                <a16:creationId xmlns:a16="http://schemas.microsoft.com/office/drawing/2014/main" id="{E6D74D4B-2525-4368-BB0B-4C6555249A0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4761" y="287161"/>
            <a:ext cx="1870593" cy="1958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Picture 8" descr="C:\Users\trs-confocal\AppData\Local\Temp\tmp12792765943840010377.png">
            <a:extLst>
              <a:ext uri="{FF2B5EF4-FFF2-40B4-BE49-F238E27FC236}">
                <a16:creationId xmlns:a16="http://schemas.microsoft.com/office/drawing/2014/main" id="{89D33E91-036E-44CF-87A8-5E7D9CB3D38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34761" y="4791026"/>
            <a:ext cx="1864269" cy="19520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Picture 12" descr="C:\Users\trs-confocal\AppData\Local\Temp\tmp1438876546080714819.png">
            <a:extLst>
              <a:ext uri="{FF2B5EF4-FFF2-40B4-BE49-F238E27FC236}">
                <a16:creationId xmlns:a16="http://schemas.microsoft.com/office/drawing/2014/main" id="{81B4CE69-EB00-487F-B578-FC75351A26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99976" y="2558919"/>
            <a:ext cx="1908621" cy="19985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3" name="ZoneTexte 62">
            <a:extLst>
              <a:ext uri="{FF2B5EF4-FFF2-40B4-BE49-F238E27FC236}">
                <a16:creationId xmlns:a16="http://schemas.microsoft.com/office/drawing/2014/main" id="{708452C0-4BE3-4E64-BF49-F7075486E26E}"/>
              </a:ext>
            </a:extLst>
          </p:cNvPr>
          <p:cNvSpPr txBox="1"/>
          <p:nvPr/>
        </p:nvSpPr>
        <p:spPr>
          <a:xfrm>
            <a:off x="5858464" y="2672720"/>
            <a:ext cx="15135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Labeled</a:t>
            </a:r>
            <a:r>
              <a:rPr lang="fr-FR" sz="1200" dirty="0"/>
              <a:t> monocytes-macrophages</a:t>
            </a:r>
          </a:p>
        </p:txBody>
      </p:sp>
      <p:sp>
        <p:nvSpPr>
          <p:cNvPr id="64" name="ZoneTexte 63">
            <a:extLst>
              <a:ext uri="{FF2B5EF4-FFF2-40B4-BE49-F238E27FC236}">
                <a16:creationId xmlns:a16="http://schemas.microsoft.com/office/drawing/2014/main" id="{93F6024C-9720-4031-A493-BA174DF4C13D}"/>
              </a:ext>
            </a:extLst>
          </p:cNvPr>
          <p:cNvSpPr txBox="1"/>
          <p:nvPr/>
        </p:nvSpPr>
        <p:spPr>
          <a:xfrm>
            <a:off x="5962830" y="4863900"/>
            <a:ext cx="15135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Labeled</a:t>
            </a:r>
            <a:r>
              <a:rPr lang="fr-FR" sz="1200" dirty="0"/>
              <a:t> monocytes-macrophages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FDF80DC0-0BF2-4269-9EF6-F968A4D5C409}"/>
              </a:ext>
            </a:extLst>
          </p:cNvPr>
          <p:cNvSpPr txBox="1"/>
          <p:nvPr/>
        </p:nvSpPr>
        <p:spPr>
          <a:xfrm>
            <a:off x="9466044" y="4821853"/>
            <a:ext cx="190862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 err="1"/>
              <a:t>Infected</a:t>
            </a:r>
            <a:r>
              <a:rPr lang="fr-FR" sz="1200" dirty="0"/>
              <a:t> </a:t>
            </a:r>
            <a:r>
              <a:rPr lang="fr-FR" sz="1200" dirty="0" err="1"/>
              <a:t>labeled</a:t>
            </a:r>
            <a:r>
              <a:rPr lang="fr-FR" sz="1200" dirty="0"/>
              <a:t> </a:t>
            </a:r>
            <a:r>
              <a:rPr lang="fr-FR" sz="1200" dirty="0" err="1"/>
              <a:t>monoctyes</a:t>
            </a:r>
            <a:r>
              <a:rPr lang="fr-FR" sz="1200" dirty="0"/>
              <a:t>-macrophages</a:t>
            </a:r>
          </a:p>
        </p:txBody>
      </p:sp>
    </p:spTree>
    <p:extLst>
      <p:ext uri="{BB962C8B-B14F-4D97-AF65-F5344CB8AC3E}">
        <p14:creationId xmlns:p14="http://schemas.microsoft.com/office/powerpoint/2010/main" val="293789801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5</Words>
  <Application>Microsoft Office PowerPoint</Application>
  <PresentationFormat>Grand écran</PresentationFormat>
  <Paragraphs>1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Roche</dc:creator>
  <cp:lastModifiedBy>Sylvie Roche</cp:lastModifiedBy>
  <cp:revision>3</cp:revision>
  <dcterms:created xsi:type="dcterms:W3CDTF">2020-06-04T06:34:48Z</dcterms:created>
  <dcterms:modified xsi:type="dcterms:W3CDTF">2020-11-05T07:27:31Z</dcterms:modified>
</cp:coreProperties>
</file>